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8" d="100"/>
          <a:sy n="48" d="100"/>
        </p:scale>
        <p:origin x="29" y="8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93C72-3A2D-4F0B-9FB9-50E7AD8ADB2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A6E78-01CE-45C7-A2A3-C2CE2B986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32075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93C72-3A2D-4F0B-9FB9-50E7AD8ADB2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A6E78-01CE-45C7-A2A3-C2CE2B986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13460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93C72-3A2D-4F0B-9FB9-50E7AD8ADB2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A6E78-01CE-45C7-A2A3-C2CE2B986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16198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93C72-3A2D-4F0B-9FB9-50E7AD8ADB2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A6E78-01CE-45C7-A2A3-C2CE2B986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28265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93C72-3A2D-4F0B-9FB9-50E7AD8ADB2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A6E78-01CE-45C7-A2A3-C2CE2B986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7529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93C72-3A2D-4F0B-9FB9-50E7AD8ADB2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A6E78-01CE-45C7-A2A3-C2CE2B986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57523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93C72-3A2D-4F0B-9FB9-50E7AD8ADB2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A6E78-01CE-45C7-A2A3-C2CE2B986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60905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93C72-3A2D-4F0B-9FB9-50E7AD8ADB2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A6E78-01CE-45C7-A2A3-C2CE2B986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5744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93C72-3A2D-4F0B-9FB9-50E7AD8ADB2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A6E78-01CE-45C7-A2A3-C2CE2B986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1746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93C72-3A2D-4F0B-9FB9-50E7AD8ADB2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A6E78-01CE-45C7-A2A3-C2CE2B986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72401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93C72-3A2D-4F0B-9FB9-50E7AD8ADB2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A6E78-01CE-45C7-A2A3-C2CE2B986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15761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793C72-3A2D-4F0B-9FB9-50E7AD8ADB2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7A6E78-01CE-45C7-A2A3-C2CE2B986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2554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0" y="766355"/>
            <a:ext cx="8968059" cy="4970643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689811" y="6093006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igure S9.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Correlation between β-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atin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inhibition activity (BIHA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, µM) and 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­, µM) for benzylate chloroquinolines against sensitive strain W2</a:t>
            </a: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15958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5:59:39Z</dcterms:created>
  <dcterms:modified xsi:type="dcterms:W3CDTF">2020-08-04T16:32:18Z</dcterms:modified>
</cp:coreProperties>
</file>